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zh-H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30" d="100"/>
          <a:sy n="130" d="100"/>
        </p:scale>
        <p:origin x="-264" y="341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HK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HK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87B76-C876-4AF2-9134-40844142C214}" type="datetimeFigureOut">
              <a:rPr lang="zh-HK" altLang="en-US" smtClean="0"/>
              <a:t>18/4/2020</a:t>
            </a:fld>
            <a:endParaRPr lang="zh-HK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4C98E-6AE9-48A2-8754-1156DABBBB4A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9019994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HK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HK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87B76-C876-4AF2-9134-40844142C214}" type="datetimeFigureOut">
              <a:rPr lang="zh-HK" altLang="en-US" smtClean="0"/>
              <a:t>18/4/2020</a:t>
            </a:fld>
            <a:endParaRPr lang="zh-HK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4C98E-6AE9-48A2-8754-1156DABBBB4A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9304405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HK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HK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87B76-C876-4AF2-9134-40844142C214}" type="datetimeFigureOut">
              <a:rPr lang="zh-HK" altLang="en-US" smtClean="0"/>
              <a:t>18/4/2020</a:t>
            </a:fld>
            <a:endParaRPr lang="zh-HK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4C98E-6AE9-48A2-8754-1156DABBBB4A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8201879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HK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HK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87B76-C876-4AF2-9134-40844142C214}" type="datetimeFigureOut">
              <a:rPr lang="zh-HK" altLang="en-US" smtClean="0"/>
              <a:t>18/4/2020</a:t>
            </a:fld>
            <a:endParaRPr lang="zh-HK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4C98E-6AE9-48A2-8754-1156DABBBB4A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3251278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HK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87B76-C876-4AF2-9134-40844142C214}" type="datetimeFigureOut">
              <a:rPr lang="zh-HK" altLang="en-US" smtClean="0"/>
              <a:t>18/4/2020</a:t>
            </a:fld>
            <a:endParaRPr lang="zh-HK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4C98E-6AE9-48A2-8754-1156DABBBB4A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4911017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HK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HK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HK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87B76-C876-4AF2-9134-40844142C214}" type="datetimeFigureOut">
              <a:rPr lang="zh-HK" altLang="en-US" smtClean="0"/>
              <a:t>18/4/2020</a:t>
            </a:fld>
            <a:endParaRPr lang="zh-HK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4C98E-6AE9-48A2-8754-1156DABBBB4A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9642745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HK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HK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HK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87B76-C876-4AF2-9134-40844142C214}" type="datetimeFigureOut">
              <a:rPr lang="zh-HK" altLang="en-US" smtClean="0"/>
              <a:t>18/4/2020</a:t>
            </a:fld>
            <a:endParaRPr lang="zh-HK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4C98E-6AE9-48A2-8754-1156DABBBB4A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4732033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HK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87B76-C876-4AF2-9134-40844142C214}" type="datetimeFigureOut">
              <a:rPr lang="zh-HK" altLang="en-US" smtClean="0"/>
              <a:t>18/4/2020</a:t>
            </a:fld>
            <a:endParaRPr lang="zh-HK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4C98E-6AE9-48A2-8754-1156DABBBB4A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11877959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87B76-C876-4AF2-9134-40844142C214}" type="datetimeFigureOut">
              <a:rPr lang="zh-HK" altLang="en-US" smtClean="0"/>
              <a:t>18/4/2020</a:t>
            </a:fld>
            <a:endParaRPr lang="zh-HK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4C98E-6AE9-48A2-8754-1156DABBBB4A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6615560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HK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HK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87B76-C876-4AF2-9134-40844142C214}" type="datetimeFigureOut">
              <a:rPr lang="zh-HK" altLang="en-US" smtClean="0"/>
              <a:t>18/4/2020</a:t>
            </a:fld>
            <a:endParaRPr lang="zh-HK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4C98E-6AE9-48A2-8754-1156DABBBB4A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4694139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HK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HK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87B76-C876-4AF2-9134-40844142C214}" type="datetimeFigureOut">
              <a:rPr lang="zh-HK" altLang="en-US" smtClean="0"/>
              <a:t>18/4/2020</a:t>
            </a:fld>
            <a:endParaRPr lang="zh-HK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4C98E-6AE9-48A2-8754-1156DABBBB4A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41274030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HK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HK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887B76-C876-4AF2-9134-40844142C214}" type="datetimeFigureOut">
              <a:rPr lang="zh-HK" altLang="en-US" smtClean="0"/>
              <a:t>18/4/2020</a:t>
            </a:fld>
            <a:endParaRPr lang="zh-HK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HK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74C98E-6AE9-48A2-8754-1156DABBBB4A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13431056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H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5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44" b="7061"/>
          <a:stretch/>
        </p:blipFill>
        <p:spPr bwMode="auto">
          <a:xfrm>
            <a:off x="76581" y="59496"/>
            <a:ext cx="3604595" cy="54074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6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15" t="1" r="26826" b="-717"/>
          <a:stretch/>
        </p:blipFill>
        <p:spPr bwMode="auto">
          <a:xfrm>
            <a:off x="76583" y="6156176"/>
            <a:ext cx="3604594" cy="29627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7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834" t="15032" b="10627"/>
          <a:stretch/>
        </p:blipFill>
        <p:spPr bwMode="auto">
          <a:xfrm>
            <a:off x="3771900" y="44507"/>
            <a:ext cx="3035766" cy="455410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8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864" r="7904" b="18773"/>
          <a:stretch/>
        </p:blipFill>
        <p:spPr bwMode="auto">
          <a:xfrm>
            <a:off x="3771900" y="4633192"/>
            <a:ext cx="3035766" cy="44958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332656" y="5560948"/>
            <a:ext cx="313249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 smtClean="0"/>
              <a:t>An umbrella with plastic curtain to cover patient during collection of air samples </a:t>
            </a:r>
            <a:endParaRPr lang="zh-TW" altLang="en-US" sz="1400" dirty="0"/>
          </a:p>
        </p:txBody>
      </p:sp>
      <p:sp>
        <p:nvSpPr>
          <p:cNvPr id="8" name="Rectangle 7"/>
          <p:cNvSpPr/>
          <p:nvPr/>
        </p:nvSpPr>
        <p:spPr>
          <a:xfrm>
            <a:off x="2836344" y="5220006"/>
            <a:ext cx="828240" cy="2160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400" dirty="0" smtClean="0">
                <a:solidFill>
                  <a:schemeClr val="tx1"/>
                </a:solidFill>
              </a:rPr>
              <a:t>Fig 1a</a:t>
            </a:r>
            <a:endParaRPr lang="zh-TW" altLang="en-US" sz="1400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2838266" y="6170846"/>
            <a:ext cx="828240" cy="2160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400" dirty="0" smtClean="0">
                <a:solidFill>
                  <a:schemeClr val="tx1"/>
                </a:solidFill>
              </a:rPr>
              <a:t>Fig 1c</a:t>
            </a:r>
            <a:endParaRPr lang="zh-TW" altLang="en-US" sz="1400" dirty="0">
              <a:solidFill>
                <a:schemeClr val="tx1"/>
              </a:solidFill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5949280" y="4648898"/>
            <a:ext cx="828240" cy="2160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400" dirty="0" smtClean="0">
                <a:solidFill>
                  <a:schemeClr val="tx1"/>
                </a:solidFill>
              </a:rPr>
              <a:t>Fig 1d</a:t>
            </a:r>
            <a:endParaRPr lang="zh-TW" altLang="en-US" sz="1400" dirty="0">
              <a:solidFill>
                <a:schemeClr val="tx1"/>
              </a:solidFill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5949280" y="4355976"/>
            <a:ext cx="828240" cy="2160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400" dirty="0" smtClean="0">
                <a:solidFill>
                  <a:schemeClr val="tx1"/>
                </a:solidFill>
              </a:rPr>
              <a:t>Fig 1b</a:t>
            </a:r>
            <a:endParaRPr lang="zh-TW" altLang="en-US" sz="14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895630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21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佈景主題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user</dc:creator>
  <cp:lastModifiedBy>Windows</cp:lastModifiedBy>
  <cp:revision>5</cp:revision>
  <dcterms:created xsi:type="dcterms:W3CDTF">2020-04-18T14:20:34Z</dcterms:created>
  <dcterms:modified xsi:type="dcterms:W3CDTF">2020-04-18T14:53:21Z</dcterms:modified>
</cp:coreProperties>
</file>